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秋山 裕太郎" initials="秋山" lastIdx="6" clrIdx="0">
    <p:extLst>
      <p:ext uri="{19B8F6BF-5375-455C-9EA6-DF929625EA0E}">
        <p15:presenceInfo xmlns:p15="http://schemas.microsoft.com/office/powerpoint/2012/main" userId="S::yakiyama@hosp.ncgm.go.jp::3ea7e63b-f474-4eec-a82d-e5f1fa819fb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7" d="100"/>
          <a:sy n="67" d="100"/>
        </p:scale>
        <p:origin x="96" y="35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chin Chalapati" userId="89f5235a-ca68-4b8e-9893-77e3eb39075e" providerId="ADAL" clId="{9C36741C-2053-4041-AB13-CAA397D3BF02}"/>
    <pc:docChg chg="modSld">
      <pc:chgData name="Sachin Chalapati" userId="89f5235a-ca68-4b8e-9893-77e3eb39075e" providerId="ADAL" clId="{9C36741C-2053-4041-AB13-CAA397D3BF02}" dt="2023-08-08T22:57:51.452" v="35" actId="400"/>
      <pc:docMkLst>
        <pc:docMk/>
      </pc:docMkLst>
      <pc:sldChg chg="modSp mod">
        <pc:chgData name="Sachin Chalapati" userId="89f5235a-ca68-4b8e-9893-77e3eb39075e" providerId="ADAL" clId="{9C36741C-2053-4041-AB13-CAA397D3BF02}" dt="2023-08-08T22:57:51.452" v="35" actId="400"/>
        <pc:sldMkLst>
          <pc:docMk/>
          <pc:sldMk cId="2390490304" sldId="256"/>
        </pc:sldMkLst>
        <pc:spChg chg="mod">
          <ac:chgData name="Sachin Chalapati" userId="89f5235a-ca68-4b8e-9893-77e3eb39075e" providerId="ADAL" clId="{9C36741C-2053-4041-AB13-CAA397D3BF02}" dt="2023-08-08T22:57:51.452" v="35" actId="400"/>
          <ac:spMkLst>
            <pc:docMk/>
            <pc:sldMk cId="2390490304" sldId="256"/>
            <ac:spMk id="2" creationId="{0E5D7A21-B306-88F2-FB1E-5720585A3534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F17CE21-252D-1BE6-D546-BC4EA54B6BC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D57BCA5-03BE-52E6-C077-8C1BBC2530C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CCEFB34-EAAF-CBA2-E384-8CDF0915F7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81F64-F39F-4D6D-ADF1-FFD8287B6DFE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A683ED0-EB83-26C9-60D9-05B591D285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40BA075-E567-C920-F532-97A1D65F3F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384CD-FBEF-4D7F-9B7B-5B282B9CF6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2999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568F088-8970-F96C-D2FF-65E6ED0E30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E947A31-B4C7-35A2-C520-FCD3715DF4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43DA2CE-B6B0-4B13-9DD1-ABE30381A3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81F64-F39F-4D6D-ADF1-FFD8287B6DFE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0DF5FC6-2B36-2E5D-84B3-2C00986641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BBB6B0D-2CEF-7610-11AF-8F36116D11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384CD-FBEF-4D7F-9B7B-5B282B9CF6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50317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3B7A503-03C2-4891-A8BF-F70E9B52DFE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2F0CA9D-074F-8327-6D73-10D87FD116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4BE5370-F5D8-B2A7-D23D-DAACEC5DF7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81F64-F39F-4D6D-ADF1-FFD8287B6DFE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B14049F-2F5E-6057-D868-96D5AD5DE4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9020558-563B-1B34-A99F-B090DA65A6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384CD-FBEF-4D7F-9B7B-5B282B9CF6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7899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11CF54E-A11A-6D1E-46A6-462CA549BE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55F536B-FA4D-9657-52DC-148B7069F53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04D47FB-C268-9A35-A414-552A67A661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81F64-F39F-4D6D-ADF1-FFD8287B6DFE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DCA5EDB-0D84-1430-F73B-85D0AD33C0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D6AF309-3692-4995-0129-D6AB13865C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384CD-FBEF-4D7F-9B7B-5B282B9CF6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80476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74D7484-B6AA-3A84-3A8D-06C3EA7609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9BF55D5-3733-9832-9EE0-182D402B40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08D5038-BCE3-DE4E-BEF7-04852D2383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81F64-F39F-4D6D-ADF1-FFD8287B6DFE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2255E27-D3AF-54C8-26FC-F9A59D6528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22C862-2870-F328-768E-8EC82AF008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384CD-FBEF-4D7F-9B7B-5B282B9CF6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24435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2CB38EB-A78F-3843-DD7B-47EAAAD393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DD2E827-8B6F-D738-5D65-448BC948339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503C62A-8A77-6CD7-89F8-1D63FDC106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56AB03B-548A-04E4-A259-61F566C874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81F64-F39F-4D6D-ADF1-FFD8287B6DFE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7FE124A-3F39-1090-1E95-DC1C677CB4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FE19BD5-3C08-9C26-D14C-546118A36D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384CD-FBEF-4D7F-9B7B-5B282B9CF6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25101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FD53DE1-9F3A-EB4B-884A-9026969C06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62D3C2E-1BCE-0C0A-74C8-9C240AD4CD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653AE87-237B-3845-3A00-35DF5E08F1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20BDDBD-4828-1339-BC98-4A09BD1DDF6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76A0A46-DD7A-8D4D-6417-B5DC65474BD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D55047B-0AC2-D970-48CE-AF96EBE85E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81F64-F39F-4D6D-ADF1-FFD8287B6DFE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4FA7C0B-7952-9296-DCFC-97813655E2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2A0969D-5536-85FF-DAFA-3FD1576ADD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384CD-FBEF-4D7F-9B7B-5B282B9CF6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6878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A24C676-8495-D0E9-435F-DFB1DC1611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E3153F1-139E-6473-8F1C-EA3BD4E159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81F64-F39F-4D6D-ADF1-FFD8287B6DFE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20BFD22-C61E-8A3E-584B-1757CDCE5C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90C05F4-5F92-F90B-7F1A-20CD5A9384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384CD-FBEF-4D7F-9B7B-5B282B9CF6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23020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411D80E-4540-5ABC-44CF-664CFBC6AE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81F64-F39F-4D6D-ADF1-FFD8287B6DFE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2229BE3-8423-EA96-5AD8-A26D197E60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9682197-F725-45B0-61BD-39A78377FB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384CD-FBEF-4D7F-9B7B-5B282B9CF6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91056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1B5642A-95C0-9426-592E-07F17E7208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C01F323-738D-2540-6F60-EAB3CBB342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C7B454F-2BCE-021D-F2B4-68E9AE357B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A465701-573C-4FBC-CF38-2207EA94EC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81F64-F39F-4D6D-ADF1-FFD8287B6DFE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9A3C86C-0CC4-E197-D862-DF8D73117C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15613BA-1F01-E7AC-ED0A-56F9CB4F01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384CD-FBEF-4D7F-9B7B-5B282B9CF6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60046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EE63C33-F6D5-3619-297D-5588351622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0AD09E1-CE8A-7753-FBEE-9A0421CF55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955BA0C-CDBA-A51B-B7CF-A0317B4938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6025DF3-96C2-B1B3-4AFF-8EF2E0400D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81F64-F39F-4D6D-ADF1-FFD8287B6DFE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23CFE88-1D68-E5F9-897C-BF0DD2F902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C3B7B0C-8F0E-0DEA-BF3F-B3220F61F7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384CD-FBEF-4D7F-9B7B-5B282B9CF6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44352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51CE7BE-8671-7546-E146-269D3EA253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6955E65-DC34-148B-AD85-A4DFABCF87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7911EF0-1F26-8AD8-AC08-9D8B122400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081F64-F39F-4D6D-ADF1-FFD8287B6DFE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CD35D8B-DDF1-77CF-6CB3-0C0C5EE647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C1D8D7F-AA25-4848-FCEC-F59F90F0A5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D384CD-FBEF-4D7F-9B7B-5B282B9CF6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77415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4">
            <a:extLst>
              <a:ext uri="{FF2B5EF4-FFF2-40B4-BE49-F238E27FC236}">
                <a16:creationId xmlns:a16="http://schemas.microsoft.com/office/drawing/2014/main" id="{54B1322E-C549-17D8-56D2-5370E44BFED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66874800"/>
              </p:ext>
            </p:extLst>
          </p:nvPr>
        </p:nvGraphicFramePr>
        <p:xfrm>
          <a:off x="1684772" y="599323"/>
          <a:ext cx="8411847" cy="46177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826962">
                  <a:extLst>
                    <a:ext uri="{9D8B030D-6E8A-4147-A177-3AD203B41FA5}">
                      <a16:colId xmlns:a16="http://schemas.microsoft.com/office/drawing/2014/main" val="2848089530"/>
                    </a:ext>
                  </a:extLst>
                </a:gridCol>
                <a:gridCol w="1186626">
                  <a:extLst>
                    <a:ext uri="{9D8B030D-6E8A-4147-A177-3AD203B41FA5}">
                      <a16:colId xmlns:a16="http://schemas.microsoft.com/office/drawing/2014/main" val="524354260"/>
                    </a:ext>
                  </a:extLst>
                </a:gridCol>
                <a:gridCol w="1284348">
                  <a:extLst>
                    <a:ext uri="{9D8B030D-6E8A-4147-A177-3AD203B41FA5}">
                      <a16:colId xmlns:a16="http://schemas.microsoft.com/office/drawing/2014/main" val="1496336305"/>
                    </a:ext>
                  </a:extLst>
                </a:gridCol>
                <a:gridCol w="1081924">
                  <a:extLst>
                    <a:ext uri="{9D8B030D-6E8A-4147-A177-3AD203B41FA5}">
                      <a16:colId xmlns:a16="http://schemas.microsoft.com/office/drawing/2014/main" val="320086689"/>
                    </a:ext>
                  </a:extLst>
                </a:gridCol>
                <a:gridCol w="1067963">
                  <a:extLst>
                    <a:ext uri="{9D8B030D-6E8A-4147-A177-3AD203B41FA5}">
                      <a16:colId xmlns:a16="http://schemas.microsoft.com/office/drawing/2014/main" val="1856859478"/>
                    </a:ext>
                  </a:extLst>
                </a:gridCol>
                <a:gridCol w="964024">
                  <a:extLst>
                    <a:ext uri="{9D8B030D-6E8A-4147-A177-3AD203B41FA5}">
                      <a16:colId xmlns:a16="http://schemas.microsoft.com/office/drawing/2014/main" val="2397289994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s (n=19) 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496144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>
                        <a:buFont typeface="Arial" panose="020B0604020202020204" pitchFamily="34" charset="0"/>
                        <a:buNone/>
                      </a:pPr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day </a:t>
                      </a:r>
                    </a:p>
                    <a:p>
                      <a:pPr algn="ctr">
                        <a:buFont typeface="Arial" panose="020B0604020202020204" pitchFamily="34" charset="0"/>
                        <a:buNone/>
                      </a:pPr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ja-JP" b="0" i="0" dirty="0">
                          <a:solidFill>
                            <a:srgbClr val="1B1E25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missible range</a:t>
                      </a:r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ood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roat swab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rine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sion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men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014209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0 </a:t>
                      </a:r>
                    </a:p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Before taking tecovirimat)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rowSpan="7"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2376753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3</a:t>
                      </a:r>
                      <a:r>
                        <a:rPr kumimoji="1" lang="ja-JP" altLang="en-US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±2)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520600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7 (±1)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2344518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10 (±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6728695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14 (±2)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2928763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21(±4)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1183288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30 (±4)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2010343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60 (±14)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6264784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120 (±14)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93808974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E5D7A21-B306-88F2-FB1E-5720585A3534}"/>
              </a:ext>
            </a:extLst>
          </p:cNvPr>
          <p:cNvSpPr txBox="1"/>
          <p:nvPr/>
        </p:nvSpPr>
        <p:spPr>
          <a:xfrm>
            <a:off x="1755321" y="5323114"/>
            <a:ext cx="829491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pendix 1. Overview of samples collected during the participation period in the </a:t>
            </a:r>
            <a:r>
              <a:rPr kumimoji="1" lang="en-US" altLang="ja-JP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copox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ial.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in lesion samples were not collected after the skin rash had disappeared. Semen samples were collected on Day 60 and Day 120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DB345132-EFB7-7F18-EAD3-0E8492C9B607}"/>
              </a:ext>
            </a:extLst>
          </p:cNvPr>
          <p:cNvCxnSpPr>
            <a:cxnSpLocks/>
          </p:cNvCxnSpPr>
          <p:nvPr/>
        </p:nvCxnSpPr>
        <p:spPr>
          <a:xfrm>
            <a:off x="9160329" y="1640957"/>
            <a:ext cx="936290" cy="2824907"/>
          </a:xfrm>
          <a:prstGeom prst="line">
            <a:avLst/>
          </a:prstGeom>
          <a:ln w="12700">
            <a:solidFill>
              <a:schemeClr val="bg2">
                <a:lumMod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904903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143</Words>
  <Application>Microsoft Office PowerPoint</Application>
  <PresentationFormat>ワイド画面</PresentationFormat>
  <Paragraphs>5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秋山 裕太郎</dc:creator>
  <cp:lastModifiedBy>森岡 慎一郎</cp:lastModifiedBy>
  <cp:revision>16</cp:revision>
  <dcterms:created xsi:type="dcterms:W3CDTF">2023-07-07T07:31:24Z</dcterms:created>
  <dcterms:modified xsi:type="dcterms:W3CDTF">2023-08-17T10:52:48Z</dcterms:modified>
</cp:coreProperties>
</file>